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5974" r:id="rId2"/>
    <p:sldId id="260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/>
    <p:restoredTop sz="94692"/>
  </p:normalViewPr>
  <p:slideViewPr>
    <p:cSldViewPr snapToGrid="0">
      <p:cViewPr varScale="1">
        <p:scale>
          <a:sx n="79" d="100"/>
          <a:sy n="79" d="100"/>
        </p:scale>
        <p:origin x="284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D8923-5C29-A040-BCF4-136B17F3305A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1563E1-3F1D-E64E-9CAD-2CF8F37E3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69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E3D2CB-36E4-CC4C-8389-D626B50AD18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405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93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50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4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1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342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141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183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057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095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703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940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39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emf"/><Relationship Id="rId21" Type="http://schemas.openxmlformats.org/officeDocument/2006/relationships/image" Target="../media/image19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252266C-ED87-D3C2-514C-66DDE78127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4677" y="514979"/>
            <a:ext cx="1306808" cy="213252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AB946AB-78E9-944C-E87E-AABEA21323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96857" y="514979"/>
            <a:ext cx="1306808" cy="213252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3EEAA59-F6FF-EC98-94E5-5C977DF6F2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87123" y="4765556"/>
            <a:ext cx="1306809" cy="213252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D145B92-AAD5-944A-D59C-A1637A4D8B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96857" y="4765556"/>
            <a:ext cx="1306809" cy="213252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85C8D95-C401-A823-E6FE-5C2941848D4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9528" y="6923425"/>
            <a:ext cx="1306809" cy="213252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97483D9-C8CA-A334-BF27-7D08EE931D5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87123" y="6923425"/>
            <a:ext cx="1306809" cy="213252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DDB0A66-BD9A-99F2-D834-97AA2437C70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31245" y="6923425"/>
            <a:ext cx="1317147" cy="213252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12314A7-AAB6-059B-5FEC-20E6A78E956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44677" y="2591750"/>
            <a:ext cx="1317147" cy="213252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027EFCA-D492-B1E3-1506-DE9FC7299C1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87124" y="2591750"/>
            <a:ext cx="1317147" cy="213252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F1B6D35-8D5B-C912-7F1B-DEEE4FE90B6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444677" y="4765556"/>
            <a:ext cx="1317147" cy="2132523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84B33261-27C4-EFF9-0038-B375C601483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31245" y="4765556"/>
            <a:ext cx="1317147" cy="2132523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5EF65F75-F45A-1ECB-7178-536CC0F208F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09529" y="4765556"/>
            <a:ext cx="1317147" cy="213252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386FCDA-E2F1-506E-ECFE-15E2A8F7418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396858" y="2591750"/>
            <a:ext cx="1317147" cy="213252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F21336B2-0D5A-4774-586B-BF5F5F427C7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9529" y="2591749"/>
            <a:ext cx="1322295" cy="214085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ACEF198-B190-7039-B90F-C7D5DE10FA4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09529" y="514979"/>
            <a:ext cx="1306640" cy="2115512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81F9A4B-FFA2-840D-C39D-46EBD706F13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087124" y="514979"/>
            <a:ext cx="1306808" cy="211578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1433602-EA51-8CAF-38B9-7F088EC2397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444677" y="6923425"/>
            <a:ext cx="1317147" cy="21325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A4B18F6-75B6-DD16-E89C-C4B6641E7C9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731245" y="514979"/>
            <a:ext cx="1321032" cy="213252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9C2AB97-32C6-78C8-EC3E-287B3CAAEA3B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731245" y="2591750"/>
            <a:ext cx="1306806" cy="211578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404CDDF-DBB1-77A9-651B-D816F804FACC}"/>
              </a:ext>
            </a:extLst>
          </p:cNvPr>
          <p:cNvSpPr txBox="1"/>
          <p:nvPr/>
        </p:nvSpPr>
        <p:spPr>
          <a:xfrm>
            <a:off x="112544" y="168813"/>
            <a:ext cx="343251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l Figure 9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987576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8B5FA8BE-E101-BD9C-7F0E-016C85DFC3A4}"/>
              </a:ext>
            </a:extLst>
          </p:cNvPr>
          <p:cNvSpPr txBox="1">
            <a:spLocks/>
          </p:cNvSpPr>
          <p:nvPr/>
        </p:nvSpPr>
        <p:spPr>
          <a:xfrm>
            <a:off x="471487" y="358247"/>
            <a:ext cx="5915025" cy="122766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00000"/>
              </a:lnSpc>
            </a:pPr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9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te-matched OA Medial vs CAD Medial Candidate m/z Comparisons across entire cohort.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tensities for 7 of 44 candidates were significantly increased in OA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ross the patient cohort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y one-sided t-test. (p&lt;0.05) 10 additional markers trended </a:t>
            </a:r>
            <a:r>
              <a:rPr lang="en-US" sz="14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wards significance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0.1 &lt; p &lt; 0.05).</a:t>
            </a:r>
            <a:endParaRPr lang="en-US" sz="14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92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60</Words>
  <Application>Microsoft Macintosh PowerPoint</Application>
  <PresentationFormat>Letter Paper (8.5x11 in)</PresentationFormat>
  <Paragraphs>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Birgit Schilling</cp:lastModifiedBy>
  <cp:revision>21</cp:revision>
  <dcterms:created xsi:type="dcterms:W3CDTF">2024-10-28T17:59:57Z</dcterms:created>
  <dcterms:modified xsi:type="dcterms:W3CDTF">2025-01-22T03:37:06Z</dcterms:modified>
</cp:coreProperties>
</file>